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68" r:id="rId4"/>
    <p:sldId id="269" r:id="rId5"/>
    <p:sldId id="27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248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2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chk17/Documents/Laterality%20Manuscript%204_29/MD%20ROC%20Curve%20Threshold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chk17/Documents/Laterality%20Manuscript%204_29/MD%20ROC%20Curve%20Threshold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chk17/Documents/Laterality%20Manuscript%204_29/MD%20ROC%20Curve%20Threshold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chk17/Documents/Laterality%20Manuscript%204_29/MD%20ROC%20Curve%20Threshold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chk17/Documents/Laterality%20Manuscript%204_29/MD%20ROC%20Curve%20Threshold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chk17/Documents/Laterality%20Manuscript%204_29/MD%20ROC%20Curve%20Threshold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300" dirty="0"/>
              <a:t>Discovery Harvard-Oxford/Discovery</a:t>
            </a:r>
            <a:r>
              <a:rPr lang="en-US" sz="1300" baseline="0" dirty="0"/>
              <a:t> AAL</a:t>
            </a:r>
          </a:p>
          <a:p>
            <a:pPr>
              <a:defRPr/>
            </a:pPr>
            <a:r>
              <a:rPr lang="en-US" sz="1300" baseline="0" dirty="0"/>
              <a:t>Right Striatum</a:t>
            </a:r>
            <a:endParaRPr lang="en-US" sz="1300" dirty="0"/>
          </a:p>
        </c:rich>
      </c:tx>
      <c:layout>
        <c:manualLayout>
          <c:xMode val="edge"/>
          <c:yMode val="edge"/>
          <c:x val="0.15869902138102807"/>
          <c:y val="0.110413761041376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O$33:$O$38</c:f>
              <c:numCache>
                <c:formatCode>General</c:formatCode>
                <c:ptCount val="6"/>
                <c:pt idx="0">
                  <c:v>0</c:v>
                </c:pt>
                <c:pt idx="1">
                  <c:v>0.2</c:v>
                </c:pt>
                <c:pt idx="2">
                  <c:v>0.4</c:v>
                </c:pt>
                <c:pt idx="3">
                  <c:v>0.6</c:v>
                </c:pt>
                <c:pt idx="4">
                  <c:v>0.8</c:v>
                </c:pt>
                <c:pt idx="5">
                  <c:v>1</c:v>
                </c:pt>
              </c:numCache>
            </c:numRef>
          </c:xVal>
          <c:yVal>
            <c:numRef>
              <c:f>Sheet1!$P$33:$P$38</c:f>
              <c:numCache>
                <c:formatCode>General</c:formatCode>
                <c:ptCount val="6"/>
                <c:pt idx="0">
                  <c:v>0</c:v>
                </c:pt>
                <c:pt idx="1">
                  <c:v>0.33300000000000002</c:v>
                </c:pt>
                <c:pt idx="2">
                  <c:v>0.81200000000000006</c:v>
                </c:pt>
                <c:pt idx="3">
                  <c:v>0.85699999999999998</c:v>
                </c:pt>
                <c:pt idx="4">
                  <c:v>0.89700000000000002</c:v>
                </c:pt>
                <c:pt idx="5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5CC-A14C-81C6-8FDDE9FC2E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0204687"/>
        <c:axId val="150219343"/>
      </c:scatterChart>
      <c:valAx>
        <c:axId val="150204687"/>
        <c:scaling>
          <c:orientation val="minMax"/>
          <c:max val="1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0219343"/>
        <c:crosses val="autoZero"/>
        <c:crossBetween val="midCat"/>
        <c:majorUnit val="0.33000000000000007"/>
      </c:valAx>
      <c:valAx>
        <c:axId val="150219343"/>
        <c:scaling>
          <c:orientation val="minMax"/>
          <c:max val="1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02046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300" dirty="0"/>
              <a:t>Discovery/Replication</a:t>
            </a:r>
          </a:p>
          <a:p>
            <a:pPr>
              <a:defRPr/>
            </a:pPr>
            <a:r>
              <a:rPr lang="en-US" sz="1300" dirty="0"/>
              <a:t>Right Striatum</a:t>
            </a:r>
          </a:p>
        </c:rich>
      </c:tx>
      <c:layout>
        <c:manualLayout>
          <c:xMode val="edge"/>
          <c:yMode val="edge"/>
          <c:x val="0.29471178341686405"/>
          <c:y val="0.2033937703393770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O$6:$O$11</c:f>
              <c:numCache>
                <c:formatCode>General</c:formatCode>
                <c:ptCount val="6"/>
                <c:pt idx="0">
                  <c:v>0</c:v>
                </c:pt>
                <c:pt idx="1">
                  <c:v>0.2</c:v>
                </c:pt>
                <c:pt idx="2">
                  <c:v>0.4</c:v>
                </c:pt>
                <c:pt idx="3">
                  <c:v>0.6</c:v>
                </c:pt>
                <c:pt idx="4">
                  <c:v>0.8</c:v>
                </c:pt>
                <c:pt idx="5">
                  <c:v>1</c:v>
                </c:pt>
              </c:numCache>
            </c:numRef>
          </c:xVal>
          <c:yVal>
            <c:numRef>
              <c:f>Sheet1!$P$6:$P$11</c:f>
              <c:numCache>
                <c:formatCode>General</c:formatCode>
                <c:ptCount val="6"/>
                <c:pt idx="0">
                  <c:v>0</c:v>
                </c:pt>
                <c:pt idx="1">
                  <c:v>9.5000000000000001E-2</c:v>
                </c:pt>
                <c:pt idx="2">
                  <c:v>0.66391752577319585</c:v>
                </c:pt>
                <c:pt idx="3">
                  <c:v>0.70553064275037369</c:v>
                </c:pt>
                <c:pt idx="4">
                  <c:v>0.81759290828503239</c:v>
                </c:pt>
                <c:pt idx="5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110-424B-930F-405DD95D9B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66245471"/>
        <c:axId val="466247119"/>
      </c:scatterChart>
      <c:valAx>
        <c:axId val="466245471"/>
        <c:scaling>
          <c:orientation val="minMax"/>
          <c:max val="1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6247119"/>
        <c:crosses val="autoZero"/>
        <c:crossBetween val="midCat"/>
        <c:majorUnit val="0.33000000000000007"/>
      </c:valAx>
      <c:valAx>
        <c:axId val="466247119"/>
        <c:scaling>
          <c:orientation val="minMax"/>
          <c:max val="1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624547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sz="1300" dirty="0"/>
              <a:t>Discovery/Replication</a:t>
            </a:r>
          </a:p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>
                <a:solidFill>
                  <a:sysClr val="windowText" lastClr="000000">
                    <a:lumMod val="65000"/>
                    <a:lumOff val="35000"/>
                  </a:sysClr>
                </a:solidFill>
              </a:defRPr>
            </a:pPr>
            <a:r>
              <a:rPr lang="en-US" sz="1300" dirty="0"/>
              <a:t>Left Striatum</a:t>
            </a:r>
          </a:p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>
                <a:solidFill>
                  <a:sysClr val="windowText" lastClr="000000">
                    <a:lumMod val="65000"/>
                    <a:lumOff val="35000"/>
                  </a:sysClr>
                </a:solidFill>
              </a:defRPr>
            </a:pPr>
            <a:endParaRPr lang="en-US" dirty="0"/>
          </a:p>
        </c:rich>
      </c:tx>
      <c:layout>
        <c:manualLayout>
          <c:xMode val="edge"/>
          <c:yMode val="edge"/>
          <c:x val="0.30437922347873569"/>
          <c:y val="0.2440725244072524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V$6:$V$11</c:f>
              <c:numCache>
                <c:formatCode>General</c:formatCode>
                <c:ptCount val="6"/>
                <c:pt idx="0">
                  <c:v>0</c:v>
                </c:pt>
                <c:pt idx="1">
                  <c:v>0.2</c:v>
                </c:pt>
                <c:pt idx="2">
                  <c:v>0.4</c:v>
                </c:pt>
                <c:pt idx="3">
                  <c:v>0.6</c:v>
                </c:pt>
                <c:pt idx="4">
                  <c:v>0.8</c:v>
                </c:pt>
                <c:pt idx="5">
                  <c:v>1</c:v>
                </c:pt>
              </c:numCache>
            </c:numRef>
          </c:xVal>
          <c:yVal>
            <c:numRef>
              <c:f>Sheet1!$W$6:$W$11</c:f>
              <c:numCache>
                <c:formatCode>General</c:formatCode>
                <c:ptCount val="6"/>
                <c:pt idx="0">
                  <c:v>0</c:v>
                </c:pt>
                <c:pt idx="1">
                  <c:v>0.32900000000000001</c:v>
                </c:pt>
                <c:pt idx="2">
                  <c:v>0.70227497527200788</c:v>
                </c:pt>
                <c:pt idx="3">
                  <c:v>0.76330461226558544</c:v>
                </c:pt>
                <c:pt idx="4">
                  <c:v>0.81759290828503239</c:v>
                </c:pt>
                <c:pt idx="5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829-2C4A-A4C2-FBB3F0BCB7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63082303"/>
        <c:axId val="523889983"/>
      </c:scatterChart>
      <c:valAx>
        <c:axId val="463082303"/>
        <c:scaling>
          <c:orientation val="minMax"/>
          <c:max val="1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3889983"/>
        <c:crosses val="autoZero"/>
        <c:crossBetween val="midCat"/>
        <c:majorUnit val="0.33000000000000007"/>
      </c:valAx>
      <c:valAx>
        <c:axId val="523889983"/>
        <c:scaling>
          <c:orientation val="minMax"/>
          <c:max val="1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308230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sz="1300" dirty="0"/>
              <a:t>Discovery Harvard-Oxford/Discovery AAL</a:t>
            </a:r>
          </a:p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>
                <a:solidFill>
                  <a:sysClr val="windowText" lastClr="000000">
                    <a:lumMod val="65000"/>
                    <a:lumOff val="35000"/>
                  </a:sysClr>
                </a:solidFill>
              </a:defRPr>
            </a:pPr>
            <a:r>
              <a:rPr lang="en-US" sz="1300" dirty="0"/>
              <a:t>Left</a:t>
            </a:r>
            <a:r>
              <a:rPr lang="en-US" sz="1300" baseline="0" dirty="0"/>
              <a:t> </a:t>
            </a:r>
            <a:r>
              <a:rPr lang="en-US" sz="1300" dirty="0"/>
              <a:t>Striatum</a:t>
            </a:r>
          </a:p>
        </c:rich>
      </c:tx>
      <c:layout>
        <c:manualLayout>
          <c:xMode val="edge"/>
          <c:yMode val="edge"/>
          <c:x val="0.14354524564939825"/>
          <c:y val="9.298000929800093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V$33:$V$38</c:f>
              <c:numCache>
                <c:formatCode>General</c:formatCode>
                <c:ptCount val="6"/>
                <c:pt idx="0">
                  <c:v>0</c:v>
                </c:pt>
                <c:pt idx="1">
                  <c:v>0.2</c:v>
                </c:pt>
                <c:pt idx="2">
                  <c:v>0.4</c:v>
                </c:pt>
                <c:pt idx="3">
                  <c:v>0.6</c:v>
                </c:pt>
                <c:pt idx="4">
                  <c:v>0.8</c:v>
                </c:pt>
                <c:pt idx="5">
                  <c:v>1</c:v>
                </c:pt>
              </c:numCache>
            </c:numRef>
          </c:xVal>
          <c:yVal>
            <c:numRef>
              <c:f>Sheet1!$W$33:$W$38</c:f>
              <c:numCache>
                <c:formatCode>General</c:formatCode>
                <c:ptCount val="6"/>
                <c:pt idx="0">
                  <c:v>0</c:v>
                </c:pt>
                <c:pt idx="1">
                  <c:v>0.60699999999999998</c:v>
                </c:pt>
                <c:pt idx="2">
                  <c:v>0.82304526748971196</c:v>
                </c:pt>
                <c:pt idx="3">
                  <c:v>0.87759336099585061</c:v>
                </c:pt>
                <c:pt idx="4">
                  <c:v>0.93945720250521925</c:v>
                </c:pt>
                <c:pt idx="5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508-9D49-8161-51DEAD875D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7303759"/>
        <c:axId val="527305407"/>
      </c:scatterChart>
      <c:valAx>
        <c:axId val="527303759"/>
        <c:scaling>
          <c:orientation val="minMax"/>
          <c:max val="1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7305407"/>
        <c:crosses val="autoZero"/>
        <c:crossBetween val="midCat"/>
        <c:majorUnit val="0.33000000000000007"/>
      </c:valAx>
      <c:valAx>
        <c:axId val="527305407"/>
        <c:scaling>
          <c:orientation val="minMax"/>
          <c:max val="1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730375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300" dirty="0"/>
              <a:t>Discovery/Left-handed</a:t>
            </a:r>
          </a:p>
          <a:p>
            <a:pPr>
              <a:defRPr/>
            </a:pPr>
            <a:r>
              <a:rPr lang="en-US" sz="1300" dirty="0"/>
              <a:t>Right Striatum</a:t>
            </a:r>
          </a:p>
        </c:rich>
      </c:tx>
      <c:layout>
        <c:manualLayout>
          <c:xMode val="edge"/>
          <c:yMode val="edge"/>
          <c:x val="0.29745901106909201"/>
          <c:y val="0.1743375174337517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O$62:$O$67</c:f>
              <c:numCache>
                <c:formatCode>General</c:formatCode>
                <c:ptCount val="6"/>
                <c:pt idx="0">
                  <c:v>0</c:v>
                </c:pt>
                <c:pt idx="1">
                  <c:v>0.2</c:v>
                </c:pt>
                <c:pt idx="2">
                  <c:v>0.4</c:v>
                </c:pt>
                <c:pt idx="3">
                  <c:v>0.6</c:v>
                </c:pt>
                <c:pt idx="4">
                  <c:v>0.8</c:v>
                </c:pt>
                <c:pt idx="5">
                  <c:v>1</c:v>
                </c:pt>
              </c:numCache>
            </c:numRef>
          </c:xVal>
          <c:yVal>
            <c:numRef>
              <c:f>Sheet1!$P$62:$P$67</c:f>
              <c:numCache>
                <c:formatCode>General</c:formatCode>
                <c:ptCount val="6"/>
                <c:pt idx="0">
                  <c:v>0</c:v>
                </c:pt>
                <c:pt idx="1">
                  <c:v>4.1000000000000002E-2</c:v>
                </c:pt>
                <c:pt idx="2">
                  <c:v>0.52993348115299332</c:v>
                </c:pt>
                <c:pt idx="3">
                  <c:v>0.67604110329908063</c:v>
                </c:pt>
                <c:pt idx="4">
                  <c:v>0.81328671328671331</c:v>
                </c:pt>
                <c:pt idx="5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023-2C4C-BC17-99F84B9C0E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63263759"/>
        <c:axId val="442858959"/>
      </c:scatterChart>
      <c:valAx>
        <c:axId val="463263759"/>
        <c:scaling>
          <c:orientation val="minMax"/>
          <c:max val="1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2858959"/>
        <c:crosses val="autoZero"/>
        <c:crossBetween val="midCat"/>
        <c:majorUnit val="0.33000000000000007"/>
      </c:valAx>
      <c:valAx>
        <c:axId val="442858959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326375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sz="1300" dirty="0"/>
              <a:t>Discovery/Left-handed</a:t>
            </a:r>
          </a:p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>
                <a:solidFill>
                  <a:sysClr val="windowText" lastClr="000000">
                    <a:lumMod val="65000"/>
                    <a:lumOff val="35000"/>
                  </a:sysClr>
                </a:solidFill>
              </a:defRPr>
            </a:pPr>
            <a:r>
              <a:rPr lang="en-US" sz="1300" dirty="0"/>
              <a:t>Left Striatum</a:t>
            </a:r>
          </a:p>
        </c:rich>
      </c:tx>
      <c:layout>
        <c:manualLayout>
          <c:xMode val="edge"/>
          <c:yMode val="edge"/>
          <c:x val="0.29745901106909201"/>
          <c:y val="0.1743375174337517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V$61:$V$66</c:f>
              <c:numCache>
                <c:formatCode>General</c:formatCode>
                <c:ptCount val="6"/>
                <c:pt idx="0">
                  <c:v>0</c:v>
                </c:pt>
                <c:pt idx="1">
                  <c:v>0.2</c:v>
                </c:pt>
                <c:pt idx="2">
                  <c:v>0.4</c:v>
                </c:pt>
                <c:pt idx="3">
                  <c:v>0.6</c:v>
                </c:pt>
                <c:pt idx="4">
                  <c:v>0.8</c:v>
                </c:pt>
                <c:pt idx="5">
                  <c:v>1</c:v>
                </c:pt>
              </c:numCache>
            </c:numRef>
          </c:xVal>
          <c:yVal>
            <c:numRef>
              <c:f>Sheet1!$W$61:$W$66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.55279503105590067</c:v>
                </c:pt>
                <c:pt idx="3">
                  <c:v>0.67920585161964475</c:v>
                </c:pt>
                <c:pt idx="4">
                  <c:v>0.79614987968374007</c:v>
                </c:pt>
                <c:pt idx="5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02E-B643-A030-094025E84B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8433151"/>
        <c:axId val="698434799"/>
      </c:scatterChart>
      <c:valAx>
        <c:axId val="698433151"/>
        <c:scaling>
          <c:orientation val="minMax"/>
          <c:max val="1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434799"/>
        <c:crosses val="autoZero"/>
        <c:crossBetween val="midCat"/>
        <c:majorUnit val="0.33000000000000007"/>
      </c:valAx>
      <c:valAx>
        <c:axId val="698434799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43315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65D45D-9862-834E-9BBA-BFB5FD7404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CB64AB-DB55-C246-8872-6041865A5C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4847F6-E3F3-AA43-AF5F-2D12D1521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F7A827-0BC0-6143-B9CA-5EC86A041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5D281E-D7DD-5A4D-BE5D-8A2166E433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515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4D870E-3E48-6C45-B805-B826C2EBEC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6C4A72-F7F1-7C47-95AA-A453F47B36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ADE981-1D76-A04F-BEDE-97424A690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DBB88B-D534-4F4A-BB4D-6846BA5886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F3B4D7-0AE7-0A4D-ABD0-519CFF2238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916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17B71A-8BF8-5B44-9177-9143691D0D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F74A58-557D-3E46-893A-7B5AB420B1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372A8D-AB95-BB4F-B808-B123B7E36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5AACB2-8A9E-7148-96C5-B8D123507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629D72-1493-7F46-8E6B-1707E663D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654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3DBA4-0DC9-3F46-BFF1-DCED7B8C2B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291810-8075-8645-A07F-4F5D4C4CB4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01A290-4DCD-FF4C-BAE1-7E56E4829E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3DF764-0D6C-C643-9B2C-E907D2DC07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D6244E-EA5D-204A-928A-BDBCBF45D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976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2ADC7F-B685-9640-B0E6-D12C08B8D3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CDCD3A-54B0-3F44-AE20-C6AFCD3738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8926F0-01A9-6F4B-AF9B-14D6D78C1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1EDF77-F9D9-9944-AEF5-F2052B89A1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F95684-66FD-2146-96ED-C9679CBE6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454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DAB4F6-0CA8-9D4C-8117-89C1C703F1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7FFE76-1589-3545-B638-57EBC5EB46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2A2510-24E4-EC4C-8355-9624FF3994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D1C186-31AE-BD40-8A4B-C48EA4FF39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9B6E70-88D0-D14D-AED3-1508B353B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841537-54A1-A041-8063-F95C2CB84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970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786F68-41C3-774C-B57E-2BE54F25BE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22E07D-49C7-B04F-B46B-C2A84922C3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62F1E0-F8D1-E24A-BAEF-4A2976F974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9E2E936-1FEF-994F-A7E1-32DE15B04D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6B58110-93EB-2649-9FB0-54E9EA4324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B1BD19-6EFF-6B4B-B353-4C204E31E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DFE7A26-D64D-8548-9BA3-0DB0D5A17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9812F85-94DE-244B-B007-387321789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703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D74A2-2E29-E146-A68C-641CFA76FB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1FF199-EA48-0140-9C6C-98D8F2DBA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F7C15BF-3D3D-D346-A777-217571A5A8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43E4E83-50AD-724F-BC13-36F2F06BC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051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2E7BB8-841C-DB40-B8DC-047746E14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45534B-0E4B-3842-B106-DDE23CAFD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24B920D-CDDB-2145-99B8-F400842D5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465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09D84C-7886-6640-ACF7-5C7ABC48C2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A52956-163A-424D-B125-97C17D01B6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8BC9FC-88E8-2942-82A4-E30517DF86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F0168C-3CA4-8647-BD77-B63BE388D3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1E3B48-86D1-8F40-B680-0086BA4AD9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C6CB85-D463-AA48-A5CB-A344C030E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379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03D4CE-D583-E942-AA22-4ED1E57FDC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9ED115-06EB-B64F-8535-4750E1F0FC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A64145-1785-FB4A-9DE6-2C02C42E18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DB3290-5474-5544-8080-E3106E245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A08772-72AF-F444-9375-4C015686A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155F54-B893-7740-AFA7-FDA699A42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948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7AB07D-6233-6842-B94D-FA492521F0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37D4B9-CD0C-5347-AF59-A51C8D6766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8060D1-9339-9743-978E-2AF2E51B41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EACECE-420B-FE48-B021-49111B227D6D}" type="datetimeFigureOut">
              <a:rPr lang="en-US" smtClean="0"/>
              <a:t>6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359203-6339-D144-B63B-1706677EE4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D7DE33-EC51-B846-B25E-20B0F4E9F3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FCDC8-746F-C742-AABD-3C6319448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770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2" Type="http://schemas.openxmlformats.org/officeDocument/2006/relationships/image" Target="../media/image1.emf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8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10" Type="http://schemas.openxmlformats.org/officeDocument/2006/relationships/image" Target="../media/image43.png"/><Relationship Id="rId4" Type="http://schemas.openxmlformats.org/officeDocument/2006/relationships/image" Target="../media/image37.emf"/><Relationship Id="rId9" Type="http://schemas.openxmlformats.org/officeDocument/2006/relationships/image" Target="../media/image42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Group 68">
            <a:extLst>
              <a:ext uri="{FF2B5EF4-FFF2-40B4-BE49-F238E27FC236}">
                <a16:creationId xmlns:a16="http://schemas.microsoft.com/office/drawing/2014/main" id="{CE74B09E-7B1D-3546-9943-CF96E4F257AC}"/>
              </a:ext>
            </a:extLst>
          </p:cNvPr>
          <p:cNvGrpSpPr/>
          <p:nvPr/>
        </p:nvGrpSpPr>
        <p:grpSpPr>
          <a:xfrm>
            <a:off x="0" y="29898"/>
            <a:ext cx="13334035" cy="6291389"/>
            <a:chOff x="10632" y="29898"/>
            <a:chExt cx="13323403" cy="6819467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5F1EFEFC-BF52-1C4D-9B0D-0FBC5CB05717}"/>
                </a:ext>
              </a:extLst>
            </p:cNvPr>
            <p:cNvGrpSpPr/>
            <p:nvPr/>
          </p:nvGrpSpPr>
          <p:grpSpPr>
            <a:xfrm>
              <a:off x="10632" y="29898"/>
              <a:ext cx="13323403" cy="6819467"/>
              <a:chOff x="10632" y="29898"/>
              <a:chExt cx="13323403" cy="6819467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D14FABDD-54C6-6449-8230-6A5F460D93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632" y="29898"/>
                <a:ext cx="12192000" cy="6819467"/>
              </a:xfrm>
              <a:prstGeom prst="rect">
                <a:avLst/>
              </a:prstGeom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C8F35F1D-0C46-8B47-9070-96C8580253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9135311" y="1130968"/>
                <a:ext cx="88900" cy="82550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5B3EF912-346F-AE48-9ED1-81964BB2BB1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803441" y="2310063"/>
                <a:ext cx="99931" cy="82296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70C9C449-186B-FD45-883E-EF4C15CF99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0230581" y="1724080"/>
                <a:ext cx="87897" cy="77556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176044B8-02DF-7444-B321-A7535248187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611604" y="2506527"/>
                <a:ext cx="93016" cy="82296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AAEC730D-7B45-6C48-8F91-2FAEF67464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704620" y="2679613"/>
                <a:ext cx="87137" cy="82296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BDE932B5-591F-474E-97CE-04069A4DDBB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966201" y="2857500"/>
                <a:ext cx="94053" cy="82296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FEF45F9B-E9E2-3649-9FA0-239093EDD7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0788964" y="2458227"/>
                <a:ext cx="100053" cy="82296"/>
              </a:xfrm>
              <a:prstGeom prst="rect">
                <a:avLst/>
              </a:prstGeom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F9AD37EA-3723-3F4D-BDB5-FE6566FB8A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9392319" y="3043989"/>
                <a:ext cx="86868" cy="82296"/>
              </a:xfrm>
              <a:prstGeom prst="rect">
                <a:avLst/>
              </a:prstGeom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CF9992F4-3C3E-A942-940D-474AAD5A37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8919909" y="1509822"/>
                <a:ext cx="92583" cy="82296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453D8BEC-E67C-294C-B03C-DE7B08E5F8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8919909" y="1876647"/>
                <a:ext cx="101600" cy="88900"/>
              </a:xfrm>
              <a:prstGeom prst="rect">
                <a:avLst/>
              </a:prstGeom>
            </p:spPr>
          </p:pic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67495B72-79D9-A74D-B4D9-F7DAB0BD4D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0498322" y="2089298"/>
                <a:ext cx="95250" cy="82550"/>
              </a:xfrm>
              <a:prstGeom prst="rect">
                <a:avLst/>
              </a:prstGeom>
            </p:spPr>
          </p:pic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07856D0E-2EAE-B247-A842-1DA2C0FF84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0498323" y="1907068"/>
                <a:ext cx="94053" cy="82296"/>
              </a:xfrm>
              <a:prstGeom prst="rect">
                <a:avLst/>
              </a:prstGeom>
            </p:spPr>
          </p:pic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81328770-46B4-A34F-9ED4-6D17E7D9CEE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9131215" y="1329070"/>
                <a:ext cx="92996" cy="88900"/>
              </a:xfrm>
              <a:prstGeom prst="rect">
                <a:avLst/>
              </a:prstGeom>
            </p:spPr>
          </p:pic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CF88BDE3-394B-E742-9849-CD58EBC0E1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9867309" y="2260097"/>
                <a:ext cx="82296" cy="82296"/>
              </a:xfrm>
              <a:prstGeom prst="rect">
                <a:avLst/>
              </a:prstGeom>
            </p:spPr>
          </p:pic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1CA23989-E2BE-8C42-B450-CECA164AC4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9097967" y="1679922"/>
                <a:ext cx="115187" cy="109580"/>
              </a:xfrm>
              <a:prstGeom prst="rect">
                <a:avLst/>
              </a:prstGeom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B795099E-250E-FF47-942E-093FB8097B1A}"/>
                  </a:ext>
                </a:extLst>
              </p:cNvPr>
              <p:cNvSpPr txBox="1"/>
              <p:nvPr/>
            </p:nvSpPr>
            <p:spPr>
              <a:xfrm>
                <a:off x="10042917" y="4864332"/>
                <a:ext cx="3291118" cy="15696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Pars Opercularis</a:t>
                </a:r>
              </a:p>
              <a:p>
                <a:r>
                  <a:rPr lang="en-US" sz="1200" dirty="0"/>
                  <a:t>Pars Triangularis</a:t>
                </a:r>
              </a:p>
              <a:p>
                <a:r>
                  <a:rPr lang="en-US" sz="1200" dirty="0"/>
                  <a:t>Pars Orbitalis</a:t>
                </a:r>
              </a:p>
              <a:p>
                <a:r>
                  <a:rPr lang="en-US" sz="1200" dirty="0"/>
                  <a:t>Rolandic Operculum</a:t>
                </a:r>
              </a:p>
              <a:p>
                <a:r>
                  <a:rPr lang="en-US" sz="1200" dirty="0"/>
                  <a:t>Supplementary Motor Area</a:t>
                </a:r>
              </a:p>
              <a:p>
                <a:r>
                  <a:rPr lang="en-US" sz="1200" dirty="0"/>
                  <a:t>Olfactory Cortex</a:t>
                </a:r>
              </a:p>
              <a:p>
                <a:r>
                  <a:rPr lang="en-US" sz="1200" dirty="0"/>
                  <a:t>Superior Frontal Gyrus, medial</a:t>
                </a:r>
              </a:p>
              <a:p>
                <a:endParaRPr lang="en-US" sz="1200" dirty="0"/>
              </a:p>
            </p:txBody>
          </p:sp>
        </p:grp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8F055B41-4B3C-3248-BAC3-2D42AE533F88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7963723" y="6254654"/>
              <a:ext cx="82296" cy="82296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F310C5EA-BFE6-BC47-BEA0-1DD00B516C51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1430296" y="5519564"/>
              <a:ext cx="91695" cy="91695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304DEF60-0AD8-0E48-80EE-F4178092C565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1165439" y="4979583"/>
              <a:ext cx="82155" cy="87290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5756805C-A8F3-AC41-B2F7-4A74E05903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11165439" y="5155574"/>
              <a:ext cx="82296" cy="82296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8B75DE02-9EF7-3C46-A52A-EE81A200FB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8887266" y="5307030"/>
              <a:ext cx="82296" cy="82296"/>
            </a:xfrm>
            <a:prstGeom prst="rect">
              <a:avLst/>
            </a:prstGeom>
          </p:spPr>
        </p:pic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00DA51B3-798F-0F4B-A594-ADEC0EA4459F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9779868" y="4938434"/>
              <a:ext cx="87441" cy="82297"/>
            </a:xfrm>
            <a:prstGeom prst="rect">
              <a:avLst/>
            </a:prstGeom>
          </p:spPr>
        </p:pic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260C12CE-9450-A046-86E8-91E92CAC7FE0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12033612" y="6063875"/>
              <a:ext cx="87441" cy="87441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E97411C1-5694-7F49-939F-767E74293618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10122377" y="6433992"/>
              <a:ext cx="92337" cy="86354"/>
            </a:xfrm>
            <a:prstGeom prst="rect">
              <a:avLst/>
            </a:prstGeom>
          </p:spPr>
        </p:pic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72B29B49-BC12-AD43-9DA5-C7F1EE9B60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8401355" y="6069020"/>
              <a:ext cx="88626" cy="82296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31C889B5-AC35-4443-86DF-F4198EC0AADC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11165439" y="5886305"/>
              <a:ext cx="89779" cy="82297"/>
            </a:xfrm>
            <a:prstGeom prst="rect">
              <a:avLst/>
            </a:prstGeom>
          </p:spPr>
        </p:pic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F6C7A985-2F1B-7449-B28E-D2B0E24D68D3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11851238" y="5702577"/>
              <a:ext cx="94054" cy="82297"/>
            </a:xfrm>
            <a:prstGeom prst="rect">
              <a:avLst/>
            </a:prstGeom>
          </p:spPr>
        </p:pic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431F6DC7-55E5-154B-867F-F953E90F0E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10081104" y="6597958"/>
              <a:ext cx="87441" cy="87441"/>
            </a:xfrm>
            <a:prstGeom prst="rect">
              <a:avLst/>
            </a:prstGeom>
          </p:spPr>
        </p:pic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49932B64-BB5A-BF41-A051-86A0D8589389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8611604" y="4757210"/>
              <a:ext cx="83432" cy="83432"/>
            </a:xfrm>
            <a:prstGeom prst="rect">
              <a:avLst/>
            </a:prstGeom>
          </p:spPr>
        </p:pic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B85B5B39-1233-E247-B3C9-5D541C18E35B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10992166" y="5339630"/>
              <a:ext cx="88900" cy="82550"/>
            </a:xfrm>
            <a:prstGeom prst="rect">
              <a:avLst/>
            </a:prstGeom>
          </p:spPr>
        </p:pic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3109DA41-3DBA-6D4D-9C49-852A48507703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9734699" y="5117834"/>
              <a:ext cx="87441" cy="87441"/>
            </a:xfrm>
            <a:prstGeom prst="rect">
              <a:avLst/>
            </a:prstGeom>
          </p:spPr>
        </p:pic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4F40B517-7CE8-9D40-90FC-F23AAA57769A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 flipV="1">
              <a:off x="9594999" y="5473285"/>
              <a:ext cx="79637" cy="92557"/>
            </a:xfrm>
            <a:prstGeom prst="rect">
              <a:avLst/>
            </a:prstGeom>
          </p:spPr>
        </p:pic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9CFFF6B4-0F9C-C947-B673-E9813F06707F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9894987" y="5886306"/>
              <a:ext cx="90526" cy="82296"/>
            </a:xfrm>
            <a:prstGeom prst="rect">
              <a:avLst/>
            </a:prstGeom>
          </p:spPr>
        </p:pic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FFBAAE54-976A-834A-9AC5-11A0A6116184}"/>
              </a:ext>
            </a:extLst>
          </p:cNvPr>
          <p:cNvSpPr txBox="1"/>
          <p:nvPr/>
        </p:nvSpPr>
        <p:spPr>
          <a:xfrm>
            <a:off x="1653209" y="6396335"/>
            <a:ext cx="44427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Colors are randomized and do not represent homologies or correspondences between atlases </a:t>
            </a:r>
          </a:p>
        </p:txBody>
      </p:sp>
    </p:spTree>
    <p:extLst>
      <p:ext uri="{BB962C8B-B14F-4D97-AF65-F5344CB8AC3E}">
        <p14:creationId xmlns:p14="http://schemas.microsoft.com/office/powerpoint/2010/main" val="33730073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39">
            <a:extLst>
              <a:ext uri="{FF2B5EF4-FFF2-40B4-BE49-F238E27FC236}">
                <a16:creationId xmlns:a16="http://schemas.microsoft.com/office/drawing/2014/main" id="{601CA41C-C238-C149-9D0C-86E96D6EF0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9409" y="646043"/>
            <a:ext cx="9022412" cy="5099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2527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C209F346-C854-C748-93A4-B7FD9FCAFFFF}"/>
              </a:ext>
            </a:extLst>
          </p:cNvPr>
          <p:cNvSpPr txBox="1"/>
          <p:nvPr/>
        </p:nvSpPr>
        <p:spPr>
          <a:xfrm>
            <a:off x="6650800" y="3403792"/>
            <a:ext cx="641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y =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2AF8CD2-EBEB-F64D-B42E-7A63AEA99774}"/>
              </a:ext>
            </a:extLst>
          </p:cNvPr>
          <p:cNvSpPr txBox="1"/>
          <p:nvPr/>
        </p:nvSpPr>
        <p:spPr>
          <a:xfrm>
            <a:off x="4552267" y="1701787"/>
            <a:ext cx="641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y = 2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00A0A50-F446-9F4F-87A3-5CAE94AED636}"/>
              </a:ext>
            </a:extLst>
          </p:cNvPr>
          <p:cNvSpPr txBox="1"/>
          <p:nvPr/>
        </p:nvSpPr>
        <p:spPr>
          <a:xfrm>
            <a:off x="6585421" y="1700881"/>
            <a:ext cx="641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y = 14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F07AECA-9AD1-404C-ADC6-30A3E94838BF}"/>
              </a:ext>
            </a:extLst>
          </p:cNvPr>
          <p:cNvSpPr txBox="1"/>
          <p:nvPr/>
        </p:nvSpPr>
        <p:spPr>
          <a:xfrm>
            <a:off x="4586135" y="5129904"/>
            <a:ext cx="641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y =-4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C5ACE37-A254-EB45-BF10-88EAEB225843}"/>
              </a:ext>
            </a:extLst>
          </p:cNvPr>
          <p:cNvSpPr txBox="1"/>
          <p:nvPr/>
        </p:nvSpPr>
        <p:spPr>
          <a:xfrm>
            <a:off x="6585420" y="5129903"/>
            <a:ext cx="641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y =-1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A100AD2-22C7-874E-96E4-BDB7B3E84FEF}"/>
              </a:ext>
            </a:extLst>
          </p:cNvPr>
          <p:cNvSpPr txBox="1"/>
          <p:nvPr/>
        </p:nvSpPr>
        <p:spPr>
          <a:xfrm>
            <a:off x="4586134" y="3415654"/>
            <a:ext cx="641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y =8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93BFD31-6644-AA4F-B217-0A7C5B1B5BCD}"/>
              </a:ext>
            </a:extLst>
          </p:cNvPr>
          <p:cNvSpPr txBox="1"/>
          <p:nvPr/>
        </p:nvSpPr>
        <p:spPr>
          <a:xfrm>
            <a:off x="5100379" y="0"/>
            <a:ext cx="2981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R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4343D21-FF52-D545-8CFF-6A30EE1EA366}"/>
              </a:ext>
            </a:extLst>
          </p:cNvPr>
          <p:cNvSpPr txBox="1"/>
          <p:nvPr/>
        </p:nvSpPr>
        <p:spPr>
          <a:xfrm>
            <a:off x="7219456" y="5201"/>
            <a:ext cx="2981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R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6D11749-59EA-4747-9BE5-901833F9ACA0}"/>
              </a:ext>
            </a:extLst>
          </p:cNvPr>
          <p:cNvSpPr txBox="1"/>
          <p:nvPr/>
        </p:nvSpPr>
        <p:spPr>
          <a:xfrm>
            <a:off x="6310686" y="0"/>
            <a:ext cx="2981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L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0C5BAE3-0482-E545-8D37-F8127F94AA51}"/>
              </a:ext>
            </a:extLst>
          </p:cNvPr>
          <p:cNvSpPr txBox="1"/>
          <p:nvPr/>
        </p:nvSpPr>
        <p:spPr>
          <a:xfrm>
            <a:off x="4197221" y="9978"/>
            <a:ext cx="2981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L</a:t>
            </a: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5E16F3DD-E090-C544-810E-937E3619B80A}"/>
              </a:ext>
            </a:extLst>
          </p:cNvPr>
          <p:cNvGrpSpPr/>
          <p:nvPr/>
        </p:nvGrpSpPr>
        <p:grpSpPr>
          <a:xfrm rot="10800000">
            <a:off x="4470054" y="5845592"/>
            <a:ext cx="2810647" cy="304271"/>
            <a:chOff x="1473390" y="5722923"/>
            <a:chExt cx="2810647" cy="304271"/>
          </a:xfrm>
        </p:grpSpPr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5E41ED82-0EFF-1941-BC6F-0970853A328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0800000">
              <a:off x="1473390" y="5722923"/>
              <a:ext cx="1483320" cy="304271"/>
            </a:xfrm>
            <a:prstGeom prst="rect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12126683-CC29-E845-BF7E-340A024724D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49013" y="5722923"/>
              <a:ext cx="1335024" cy="287841"/>
            </a:xfrm>
            <a:prstGeom prst="rect">
              <a:avLst/>
            </a:prstGeom>
          </p:spPr>
        </p:pic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id="{74B01FA8-B803-B54B-9D18-BC4D1569D35D}"/>
              </a:ext>
            </a:extLst>
          </p:cNvPr>
          <p:cNvSpPr txBox="1"/>
          <p:nvPr/>
        </p:nvSpPr>
        <p:spPr>
          <a:xfrm>
            <a:off x="5671828" y="5552966"/>
            <a:ext cx="35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E78095E-C70B-C344-9246-94C0138439D1}"/>
              </a:ext>
            </a:extLst>
          </p:cNvPr>
          <p:cNvSpPr txBox="1"/>
          <p:nvPr/>
        </p:nvSpPr>
        <p:spPr>
          <a:xfrm>
            <a:off x="6824128" y="5563405"/>
            <a:ext cx="8219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0.56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8133FF7-415D-F64A-9A8F-5B959BE35AE8}"/>
              </a:ext>
            </a:extLst>
          </p:cNvPr>
          <p:cNvSpPr txBox="1"/>
          <p:nvPr/>
        </p:nvSpPr>
        <p:spPr>
          <a:xfrm>
            <a:off x="4218783" y="5552966"/>
            <a:ext cx="8219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0.56</a:t>
            </a: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640A5078-8752-7949-9C73-ECB8EB0366BF}"/>
              </a:ext>
            </a:extLst>
          </p:cNvPr>
          <p:cNvGrpSpPr/>
          <p:nvPr/>
        </p:nvGrpSpPr>
        <p:grpSpPr>
          <a:xfrm>
            <a:off x="5888770" y="6209210"/>
            <a:ext cx="1440180" cy="355600"/>
            <a:chOff x="0" y="0"/>
            <a:chExt cx="1440266" cy="355855"/>
          </a:xfrm>
        </p:grpSpPr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BE72EEDF-B583-124F-A560-FB2F81C0BD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59994" b="16206"/>
            <a:stretch/>
          </p:blipFill>
          <p:spPr>
            <a:xfrm>
              <a:off x="0" y="0"/>
              <a:ext cx="435066" cy="321179"/>
            </a:xfrm>
            <a:prstGeom prst="rect">
              <a:avLst/>
            </a:prstGeom>
          </p:spPr>
        </p:pic>
        <p:sp>
          <p:nvSpPr>
            <p:cNvPr id="72" name="TextBox 66">
              <a:extLst>
                <a:ext uri="{FF2B5EF4-FFF2-40B4-BE49-F238E27FC236}">
                  <a16:creationId xmlns:a16="http://schemas.microsoft.com/office/drawing/2014/main" id="{4ABAADCE-92E7-D247-B515-76F1BFD5A24C}"/>
                </a:ext>
              </a:extLst>
            </p:cNvPr>
            <p:cNvSpPr txBox="1"/>
            <p:nvPr/>
          </p:nvSpPr>
          <p:spPr>
            <a:xfrm>
              <a:off x="329016" y="51055"/>
              <a:ext cx="1111250" cy="304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H</a:t>
              </a:r>
              <a:r>
                <a:rPr lang="en-US" sz="1200" b="1" kern="1200" baseline="-25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Z</a:t>
              </a:r>
              <a:r>
                <a:rPr lang="en-US" sz="1200" b="1" i="1" kern="1200" baseline="-25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- </a:t>
              </a:r>
              <a:r>
                <a:rPr lang="en-US" sz="1200" b="1" kern="12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LH</a:t>
              </a:r>
              <a:r>
                <a:rPr lang="en-US" sz="1200" b="1" kern="1200" baseline="-25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Zi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id="{1D631516-517B-FA4A-8191-618516998A47}"/>
              </a:ext>
            </a:extLst>
          </p:cNvPr>
          <p:cNvGrpSpPr/>
          <p:nvPr/>
        </p:nvGrpSpPr>
        <p:grpSpPr>
          <a:xfrm>
            <a:off x="4520312" y="6213075"/>
            <a:ext cx="1440180" cy="328018"/>
            <a:chOff x="0" y="0"/>
            <a:chExt cx="1440266" cy="328253"/>
          </a:xfrm>
        </p:grpSpPr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5EB757D9-A66B-9548-9CD9-62E8D59575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59994" b="16206"/>
            <a:stretch/>
          </p:blipFill>
          <p:spPr>
            <a:xfrm>
              <a:off x="0" y="0"/>
              <a:ext cx="435066" cy="321179"/>
            </a:xfrm>
            <a:prstGeom prst="rect">
              <a:avLst/>
            </a:prstGeom>
          </p:spPr>
        </p:pic>
        <p:sp>
          <p:nvSpPr>
            <p:cNvPr id="79" name="TextBox 66">
              <a:extLst>
                <a:ext uri="{FF2B5EF4-FFF2-40B4-BE49-F238E27FC236}">
                  <a16:creationId xmlns:a16="http://schemas.microsoft.com/office/drawing/2014/main" id="{F1CADE69-C736-0147-9D5D-96F4E157EB41}"/>
                </a:ext>
              </a:extLst>
            </p:cNvPr>
            <p:cNvSpPr txBox="1"/>
            <p:nvPr/>
          </p:nvSpPr>
          <p:spPr>
            <a:xfrm>
              <a:off x="329016" y="51055"/>
              <a:ext cx="1111250" cy="2771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L</a:t>
              </a:r>
              <a:r>
                <a:rPr lang="en-US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</a:t>
              </a:r>
              <a:r>
                <a:rPr lang="en-US" sz="1200" b="1" kern="1200" baseline="-25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Z</a:t>
              </a:r>
              <a:r>
                <a:rPr lang="en-US" sz="1200" b="1" i="1" kern="1200" baseline="-25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- </a:t>
              </a:r>
              <a:r>
                <a:rPr lang="en-US" sz="1200" b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R</a:t>
              </a:r>
              <a:r>
                <a:rPr lang="en-US" sz="1200" b="1" kern="12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</a:t>
              </a:r>
              <a:r>
                <a:rPr lang="en-US" sz="1200" b="1" kern="1200" baseline="-25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Zi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pic>
        <p:nvPicPr>
          <p:cNvPr id="24" name="Picture 23" descr="A picture containing vector graphics&#10;&#10;Description automatically generated">
            <a:extLst>
              <a:ext uri="{FF2B5EF4-FFF2-40B4-BE49-F238E27FC236}">
                <a16:creationId xmlns:a16="http://schemas.microsoft.com/office/drawing/2014/main" id="{6C99CDCE-19E8-A04C-972B-83429DFD362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3848831" y="323976"/>
            <a:ext cx="1948549" cy="137781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ECE0258F-B282-E04A-9E4D-C953BDF1A13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5915740" y="312978"/>
            <a:ext cx="1947675" cy="1382702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8CAC2D77-38E5-4846-9A11-08F02C74974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3848680" y="2029803"/>
            <a:ext cx="1956398" cy="1369215"/>
          </a:xfrm>
          <a:prstGeom prst="rect">
            <a:avLst/>
          </a:prstGeom>
        </p:spPr>
      </p:pic>
      <p:pic>
        <p:nvPicPr>
          <p:cNvPr id="32" name="Picture 31" descr="A picture containing toy&#10;&#10;Description automatically generated">
            <a:extLst>
              <a:ext uri="{FF2B5EF4-FFF2-40B4-BE49-F238E27FC236}">
                <a16:creationId xmlns:a16="http://schemas.microsoft.com/office/drawing/2014/main" id="{C29FF986-20A7-754A-A5C6-CB1E4CDC453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H="1">
            <a:off x="5915740" y="2028898"/>
            <a:ext cx="1947675" cy="1363960"/>
          </a:xfrm>
          <a:prstGeom prst="rect">
            <a:avLst/>
          </a:prstGeom>
        </p:spPr>
      </p:pic>
      <p:pic>
        <p:nvPicPr>
          <p:cNvPr id="47" name="Picture 46" descr="A picture containing toy&#10;&#10;Description automatically generated">
            <a:extLst>
              <a:ext uri="{FF2B5EF4-FFF2-40B4-BE49-F238E27FC236}">
                <a16:creationId xmlns:a16="http://schemas.microsoft.com/office/drawing/2014/main" id="{4945EDDF-145E-FD46-9F92-607A9ACFB2D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3840745" y="3705102"/>
            <a:ext cx="1956399" cy="1397781"/>
          </a:xfrm>
          <a:prstGeom prst="rect">
            <a:avLst/>
          </a:prstGeom>
        </p:spPr>
      </p:pic>
      <p:pic>
        <p:nvPicPr>
          <p:cNvPr id="51" name="Picture 50" descr="A picture containing toy&#10;&#10;Description automatically generated">
            <a:extLst>
              <a:ext uri="{FF2B5EF4-FFF2-40B4-BE49-F238E27FC236}">
                <a16:creationId xmlns:a16="http://schemas.microsoft.com/office/drawing/2014/main" id="{54A57BD7-AAA4-D84C-ABB9-0ECE6233434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flipH="1">
            <a:off x="5911356" y="3692653"/>
            <a:ext cx="1947675" cy="14102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57663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>
            <a:extLst>
              <a:ext uri="{FF2B5EF4-FFF2-40B4-BE49-F238E27FC236}">
                <a16:creationId xmlns:a16="http://schemas.microsoft.com/office/drawing/2014/main" id="{3109D0B9-9396-4E44-B7A0-0F3D33C0D2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0217" y="822325"/>
            <a:ext cx="8509596" cy="5213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80342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4" name="Chart 93">
            <a:extLst>
              <a:ext uri="{FF2B5EF4-FFF2-40B4-BE49-F238E27FC236}">
                <a16:creationId xmlns:a16="http://schemas.microsoft.com/office/drawing/2014/main" id="{FF85178C-7633-0C4F-ADC3-441A05DCC0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7737185"/>
              </p:ext>
            </p:extLst>
          </p:nvPr>
        </p:nvGraphicFramePr>
        <p:xfrm>
          <a:off x="1555155" y="2047627"/>
          <a:ext cx="3941064" cy="2185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5" name="Chart 54">
            <a:extLst>
              <a:ext uri="{FF2B5EF4-FFF2-40B4-BE49-F238E27FC236}">
                <a16:creationId xmlns:a16="http://schemas.microsoft.com/office/drawing/2014/main" id="{2281B438-3617-FC46-A21A-CAB2DDE8F3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7148258"/>
              </p:ext>
            </p:extLst>
          </p:nvPr>
        </p:nvGraphicFramePr>
        <p:xfrm>
          <a:off x="1568869" y="-427406"/>
          <a:ext cx="3941064" cy="2185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1B7C30A7-4E46-4E46-A724-C99498C44D88}"/>
              </a:ext>
            </a:extLst>
          </p:cNvPr>
          <p:cNvSpPr txBox="1"/>
          <p:nvPr/>
        </p:nvSpPr>
        <p:spPr>
          <a:xfrm>
            <a:off x="2172437" y="1973118"/>
            <a:ext cx="29821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anhattan Distance Distribution Threshol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EA41BCB-3B9F-E540-A763-08217FCB377B}"/>
              </a:ext>
            </a:extLst>
          </p:cNvPr>
          <p:cNvSpPr txBox="1"/>
          <p:nvPr/>
        </p:nvSpPr>
        <p:spPr>
          <a:xfrm rot="16200000">
            <a:off x="332400" y="926130"/>
            <a:ext cx="2093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Dice Coefficien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750D53C-ED4C-704F-B97B-2EBDAF4F06C7}"/>
              </a:ext>
            </a:extLst>
          </p:cNvPr>
          <p:cNvSpPr txBox="1"/>
          <p:nvPr/>
        </p:nvSpPr>
        <p:spPr>
          <a:xfrm>
            <a:off x="2172436" y="4356535"/>
            <a:ext cx="29821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anhattan Distance Distribution Threshol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BA8C6F5-585C-EA43-9D93-75CB266DC877}"/>
              </a:ext>
            </a:extLst>
          </p:cNvPr>
          <p:cNvSpPr txBox="1"/>
          <p:nvPr/>
        </p:nvSpPr>
        <p:spPr>
          <a:xfrm rot="16200000">
            <a:off x="332401" y="3225331"/>
            <a:ext cx="2093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Dice Coefficien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0154992-A5B6-B34D-AA45-23F498914882}"/>
              </a:ext>
            </a:extLst>
          </p:cNvPr>
          <p:cNvSpPr txBox="1"/>
          <p:nvPr/>
        </p:nvSpPr>
        <p:spPr>
          <a:xfrm>
            <a:off x="2242857" y="6615080"/>
            <a:ext cx="29821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anhattan Distance Distribution Threshol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26BC098-F2FE-5644-A5AE-4B26FBC706AC}"/>
              </a:ext>
            </a:extLst>
          </p:cNvPr>
          <p:cNvSpPr txBox="1"/>
          <p:nvPr/>
        </p:nvSpPr>
        <p:spPr>
          <a:xfrm rot="16200000">
            <a:off x="402822" y="5540438"/>
            <a:ext cx="2093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Dice Coefficien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9448B01-66F2-0446-8B2F-EA1B84514077}"/>
              </a:ext>
            </a:extLst>
          </p:cNvPr>
          <p:cNvSpPr txBox="1"/>
          <p:nvPr/>
        </p:nvSpPr>
        <p:spPr>
          <a:xfrm>
            <a:off x="7595919" y="1971429"/>
            <a:ext cx="29821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anhattan Distance Distribution Threshol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8A9DD4E-3B99-0042-BA8E-655367298AF8}"/>
              </a:ext>
            </a:extLst>
          </p:cNvPr>
          <p:cNvSpPr txBox="1"/>
          <p:nvPr/>
        </p:nvSpPr>
        <p:spPr>
          <a:xfrm rot="16200000">
            <a:off x="5748736" y="926130"/>
            <a:ext cx="2093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Dice Coefficien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2C21F42-C3BB-5649-97F7-2CA03AD3283C}"/>
              </a:ext>
            </a:extLst>
          </p:cNvPr>
          <p:cNvSpPr txBox="1"/>
          <p:nvPr/>
        </p:nvSpPr>
        <p:spPr>
          <a:xfrm>
            <a:off x="7622195" y="4402463"/>
            <a:ext cx="29821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anhattan Distance Distribution Threshol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6A74758-B640-8E42-BEE3-82E89F38AC0C}"/>
              </a:ext>
            </a:extLst>
          </p:cNvPr>
          <p:cNvSpPr txBox="1"/>
          <p:nvPr/>
        </p:nvSpPr>
        <p:spPr>
          <a:xfrm rot="16200000">
            <a:off x="5731487" y="3220905"/>
            <a:ext cx="2093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Dice Coefficien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5356681-1955-4840-B924-F81510ACF703}"/>
              </a:ext>
            </a:extLst>
          </p:cNvPr>
          <p:cNvSpPr txBox="1"/>
          <p:nvPr/>
        </p:nvSpPr>
        <p:spPr>
          <a:xfrm>
            <a:off x="7570575" y="6614859"/>
            <a:ext cx="29821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anhattan Distance Distribution Threshold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BC80F34-59F0-974E-96DB-8EB7E9506F5D}"/>
              </a:ext>
            </a:extLst>
          </p:cNvPr>
          <p:cNvSpPr txBox="1"/>
          <p:nvPr/>
        </p:nvSpPr>
        <p:spPr>
          <a:xfrm rot="16200000">
            <a:off x="5730540" y="5521363"/>
            <a:ext cx="2093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Dice Coefficient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DAF15E4-B221-A942-A877-CD715A647DB0}"/>
              </a:ext>
            </a:extLst>
          </p:cNvPr>
          <p:cNvSpPr txBox="1"/>
          <p:nvPr/>
        </p:nvSpPr>
        <p:spPr>
          <a:xfrm>
            <a:off x="4523794" y="1294901"/>
            <a:ext cx="962612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dirty="0"/>
              <a:t>AUC = 0.556  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D522C7E-0283-A342-8D75-3EA9BA0D88C2}"/>
              </a:ext>
            </a:extLst>
          </p:cNvPr>
          <p:cNvSpPr txBox="1"/>
          <p:nvPr/>
        </p:nvSpPr>
        <p:spPr>
          <a:xfrm>
            <a:off x="4523794" y="3770140"/>
            <a:ext cx="962612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dirty="0"/>
              <a:t>AUC = 0.680 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42891A1-47C2-6A41-88D4-42BDCAD8640E}"/>
              </a:ext>
            </a:extLst>
          </p:cNvPr>
          <p:cNvSpPr txBox="1"/>
          <p:nvPr/>
        </p:nvSpPr>
        <p:spPr>
          <a:xfrm>
            <a:off x="4522540" y="6049149"/>
            <a:ext cx="962612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dirty="0"/>
              <a:t>AUC = 0.512  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F31BBEE-249A-E547-91CF-020A7502041C}"/>
              </a:ext>
            </a:extLst>
          </p:cNvPr>
          <p:cNvSpPr txBox="1"/>
          <p:nvPr/>
        </p:nvSpPr>
        <p:spPr>
          <a:xfrm>
            <a:off x="9952653" y="1337044"/>
            <a:ext cx="962612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dirty="0"/>
              <a:t>AUC = 0.622  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BA1E937-07F9-F44C-B096-BBAE71979181}"/>
              </a:ext>
            </a:extLst>
          </p:cNvPr>
          <p:cNvSpPr txBox="1"/>
          <p:nvPr/>
        </p:nvSpPr>
        <p:spPr>
          <a:xfrm>
            <a:off x="9952653" y="3805711"/>
            <a:ext cx="962612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dirty="0"/>
              <a:t>AUC = 0.749  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3EE64B9-60CB-0C48-A50A-5FBC0442BF41}"/>
              </a:ext>
            </a:extLst>
          </p:cNvPr>
          <p:cNvSpPr txBox="1"/>
          <p:nvPr/>
        </p:nvSpPr>
        <p:spPr>
          <a:xfrm>
            <a:off x="9952653" y="6039721"/>
            <a:ext cx="962612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dirty="0"/>
              <a:t>AUC = 0.506 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5BCB684-4CD1-304F-9F8C-8991BC31C47C}"/>
              </a:ext>
            </a:extLst>
          </p:cNvPr>
          <p:cNvGrpSpPr/>
          <p:nvPr/>
        </p:nvGrpSpPr>
        <p:grpSpPr>
          <a:xfrm>
            <a:off x="1521652" y="1586540"/>
            <a:ext cx="4174818" cy="400110"/>
            <a:chOff x="1521652" y="1586540"/>
            <a:chExt cx="4174818" cy="400110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F54303C-9FAD-0141-9774-CC7BE4E55EA9}"/>
                </a:ext>
              </a:extLst>
            </p:cNvPr>
            <p:cNvSpPr txBox="1"/>
            <p:nvPr/>
          </p:nvSpPr>
          <p:spPr>
            <a:xfrm>
              <a:off x="2198037" y="1586540"/>
              <a:ext cx="7537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IQR </a:t>
              </a:r>
            </a:p>
            <a:p>
              <a:pPr algn="ctr"/>
              <a:r>
                <a:rPr lang="en-US" sz="1000" dirty="0"/>
                <a:t>Outlier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869CC21-63A9-AE4C-AD4F-C384B4CF15CA}"/>
                </a:ext>
              </a:extLst>
            </p:cNvPr>
            <p:cNvSpPr txBox="1"/>
            <p:nvPr/>
          </p:nvSpPr>
          <p:spPr>
            <a:xfrm>
              <a:off x="2825936" y="1633531"/>
              <a:ext cx="8633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F4C2104-F809-9347-B070-A407624D50D9}"/>
                </a:ext>
              </a:extLst>
            </p:cNvPr>
            <p:cNvSpPr txBox="1"/>
            <p:nvPr/>
          </p:nvSpPr>
          <p:spPr>
            <a:xfrm>
              <a:off x="3593682" y="1633532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edian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AF5DF18-427D-684D-ABA3-AD88FBA3384C}"/>
                </a:ext>
              </a:extLst>
            </p:cNvPr>
            <p:cNvSpPr txBox="1"/>
            <p:nvPr/>
          </p:nvSpPr>
          <p:spPr>
            <a:xfrm>
              <a:off x="4279112" y="1631970"/>
              <a:ext cx="8921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1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CA2E7C6-C817-754D-9E86-857A23DA049C}"/>
                </a:ext>
              </a:extLst>
            </p:cNvPr>
            <p:cNvSpPr txBox="1"/>
            <p:nvPr/>
          </p:nvSpPr>
          <p:spPr>
            <a:xfrm>
              <a:off x="1521652" y="1626931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ax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273ED607-0435-A644-ACD8-B4B4BEBAB863}"/>
                </a:ext>
              </a:extLst>
            </p:cNvPr>
            <p:cNvSpPr txBox="1"/>
            <p:nvPr/>
          </p:nvSpPr>
          <p:spPr>
            <a:xfrm>
              <a:off x="4942707" y="1628425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in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A942DB05-BE17-1543-B8F8-3A13755231A7}"/>
              </a:ext>
            </a:extLst>
          </p:cNvPr>
          <p:cNvGrpSpPr/>
          <p:nvPr/>
        </p:nvGrpSpPr>
        <p:grpSpPr>
          <a:xfrm>
            <a:off x="6933944" y="1580629"/>
            <a:ext cx="4174818" cy="400110"/>
            <a:chOff x="1521652" y="1586540"/>
            <a:chExt cx="4174818" cy="400110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B38CFB91-770C-E642-A265-36807EFD1867}"/>
                </a:ext>
              </a:extLst>
            </p:cNvPr>
            <p:cNvSpPr txBox="1"/>
            <p:nvPr/>
          </p:nvSpPr>
          <p:spPr>
            <a:xfrm>
              <a:off x="2198037" y="1586540"/>
              <a:ext cx="7537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IQR </a:t>
              </a:r>
            </a:p>
            <a:p>
              <a:pPr algn="ctr"/>
              <a:r>
                <a:rPr lang="en-US" sz="1000" dirty="0"/>
                <a:t>Outlier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5AC3638-7836-3B43-B177-A8C092F09FE4}"/>
                </a:ext>
              </a:extLst>
            </p:cNvPr>
            <p:cNvSpPr txBox="1"/>
            <p:nvPr/>
          </p:nvSpPr>
          <p:spPr>
            <a:xfrm>
              <a:off x="2825936" y="1633531"/>
              <a:ext cx="8633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3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CB51F0A-E813-C845-8202-A49CB666DBC5}"/>
                </a:ext>
              </a:extLst>
            </p:cNvPr>
            <p:cNvSpPr txBox="1"/>
            <p:nvPr/>
          </p:nvSpPr>
          <p:spPr>
            <a:xfrm>
              <a:off x="3593682" y="1633532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edian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172CA623-78C8-E84A-9828-CB140C214084}"/>
                </a:ext>
              </a:extLst>
            </p:cNvPr>
            <p:cNvSpPr txBox="1"/>
            <p:nvPr/>
          </p:nvSpPr>
          <p:spPr>
            <a:xfrm>
              <a:off x="4279112" y="1631970"/>
              <a:ext cx="8921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1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89010F58-E586-814E-BEE3-AEB09C9BC516}"/>
                </a:ext>
              </a:extLst>
            </p:cNvPr>
            <p:cNvSpPr txBox="1"/>
            <p:nvPr/>
          </p:nvSpPr>
          <p:spPr>
            <a:xfrm>
              <a:off x="1521652" y="1626931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ax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385E32ED-365D-1D42-A5D5-BD05AA368A1A}"/>
                </a:ext>
              </a:extLst>
            </p:cNvPr>
            <p:cNvSpPr txBox="1"/>
            <p:nvPr/>
          </p:nvSpPr>
          <p:spPr>
            <a:xfrm>
              <a:off x="4942707" y="1628425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in</a:t>
              </a:r>
            </a:p>
          </p:txBody>
        </p:sp>
      </p:grpSp>
      <p:graphicFrame>
        <p:nvGraphicFramePr>
          <p:cNvPr id="65" name="Chart 64">
            <a:extLst>
              <a:ext uri="{FF2B5EF4-FFF2-40B4-BE49-F238E27FC236}">
                <a16:creationId xmlns:a16="http://schemas.microsoft.com/office/drawing/2014/main" id="{9D28AAAD-719F-5145-B916-CAAE7AF59E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4623532"/>
              </p:ext>
            </p:extLst>
          </p:nvPr>
        </p:nvGraphicFramePr>
        <p:xfrm>
          <a:off x="6933944" y="-584463"/>
          <a:ext cx="3888180" cy="23682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66" name="Group 65">
            <a:extLst>
              <a:ext uri="{FF2B5EF4-FFF2-40B4-BE49-F238E27FC236}">
                <a16:creationId xmlns:a16="http://schemas.microsoft.com/office/drawing/2014/main" id="{0C6F6688-4363-FB4E-BACC-10E742BE6C67}"/>
              </a:ext>
            </a:extLst>
          </p:cNvPr>
          <p:cNvGrpSpPr/>
          <p:nvPr/>
        </p:nvGrpSpPr>
        <p:grpSpPr>
          <a:xfrm>
            <a:off x="1534356" y="4058927"/>
            <a:ext cx="4174818" cy="400110"/>
            <a:chOff x="1521652" y="1586540"/>
            <a:chExt cx="4174818" cy="400110"/>
          </a:xfrm>
        </p:grpSpPr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80B8BA02-7816-F643-AB74-B93509DB9EB7}"/>
                </a:ext>
              </a:extLst>
            </p:cNvPr>
            <p:cNvSpPr txBox="1"/>
            <p:nvPr/>
          </p:nvSpPr>
          <p:spPr>
            <a:xfrm>
              <a:off x="2198037" y="1586540"/>
              <a:ext cx="7537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IQR </a:t>
              </a:r>
            </a:p>
            <a:p>
              <a:pPr algn="ctr"/>
              <a:r>
                <a:rPr lang="en-US" sz="1000" dirty="0"/>
                <a:t>Outlier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3F649D6D-28F5-1A45-ABAF-86ABD760C24C}"/>
                </a:ext>
              </a:extLst>
            </p:cNvPr>
            <p:cNvSpPr txBox="1"/>
            <p:nvPr/>
          </p:nvSpPr>
          <p:spPr>
            <a:xfrm>
              <a:off x="2825936" y="1633531"/>
              <a:ext cx="8633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3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77A3058-47D9-244F-BA62-4187DCF77F10}"/>
                </a:ext>
              </a:extLst>
            </p:cNvPr>
            <p:cNvSpPr txBox="1"/>
            <p:nvPr/>
          </p:nvSpPr>
          <p:spPr>
            <a:xfrm>
              <a:off x="3593682" y="1633532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edian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C674F44F-93CB-7249-BB63-A2B56CA57587}"/>
                </a:ext>
              </a:extLst>
            </p:cNvPr>
            <p:cNvSpPr txBox="1"/>
            <p:nvPr/>
          </p:nvSpPr>
          <p:spPr>
            <a:xfrm>
              <a:off x="4279112" y="1631970"/>
              <a:ext cx="8921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1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39044284-09D0-1D49-B732-BC4FEBBBE434}"/>
                </a:ext>
              </a:extLst>
            </p:cNvPr>
            <p:cNvSpPr txBox="1"/>
            <p:nvPr/>
          </p:nvSpPr>
          <p:spPr>
            <a:xfrm>
              <a:off x="1521652" y="1626931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ax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E3DA2745-BD37-634E-8CD5-05B50CA2AEEE}"/>
                </a:ext>
              </a:extLst>
            </p:cNvPr>
            <p:cNvSpPr txBox="1"/>
            <p:nvPr/>
          </p:nvSpPr>
          <p:spPr>
            <a:xfrm>
              <a:off x="4942707" y="1628425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in</a:t>
              </a:r>
            </a:p>
          </p:txBody>
        </p:sp>
      </p:grpSp>
      <p:grpSp>
        <p:nvGrpSpPr>
          <p:cNvPr id="73" name="Group 72">
            <a:extLst>
              <a:ext uri="{FF2B5EF4-FFF2-40B4-BE49-F238E27FC236}">
                <a16:creationId xmlns:a16="http://schemas.microsoft.com/office/drawing/2014/main" id="{BF6FE81D-FE74-0F46-AB9D-CD89E67D0F15}"/>
              </a:ext>
            </a:extLst>
          </p:cNvPr>
          <p:cNvGrpSpPr/>
          <p:nvPr/>
        </p:nvGrpSpPr>
        <p:grpSpPr>
          <a:xfrm>
            <a:off x="6945012" y="4059303"/>
            <a:ext cx="4174818" cy="400110"/>
            <a:chOff x="1521652" y="1586540"/>
            <a:chExt cx="4174818" cy="400110"/>
          </a:xfrm>
        </p:grpSpPr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4BE9FEC7-C387-9047-B81D-6BEA79C7BFA3}"/>
                </a:ext>
              </a:extLst>
            </p:cNvPr>
            <p:cNvSpPr txBox="1"/>
            <p:nvPr/>
          </p:nvSpPr>
          <p:spPr>
            <a:xfrm>
              <a:off x="2198037" y="1586540"/>
              <a:ext cx="7537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IQR </a:t>
              </a:r>
            </a:p>
            <a:p>
              <a:pPr algn="ctr"/>
              <a:r>
                <a:rPr lang="en-US" sz="1000" dirty="0"/>
                <a:t>Outlier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689FB220-B7D2-904E-AFD6-818F69D56D13}"/>
                </a:ext>
              </a:extLst>
            </p:cNvPr>
            <p:cNvSpPr txBox="1"/>
            <p:nvPr/>
          </p:nvSpPr>
          <p:spPr>
            <a:xfrm>
              <a:off x="2825936" y="1633531"/>
              <a:ext cx="8633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3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BFB67F2-CEB0-A045-8CD2-9ECC63EBCFFE}"/>
                </a:ext>
              </a:extLst>
            </p:cNvPr>
            <p:cNvSpPr txBox="1"/>
            <p:nvPr/>
          </p:nvSpPr>
          <p:spPr>
            <a:xfrm>
              <a:off x="3593682" y="1633532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edian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DA41063-B3B5-224B-B268-E0178D5F3897}"/>
                </a:ext>
              </a:extLst>
            </p:cNvPr>
            <p:cNvSpPr txBox="1"/>
            <p:nvPr/>
          </p:nvSpPr>
          <p:spPr>
            <a:xfrm>
              <a:off x="4279112" y="1631970"/>
              <a:ext cx="8921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1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4E4A0A98-AD6D-1447-ACF1-8CBA2E06AED0}"/>
                </a:ext>
              </a:extLst>
            </p:cNvPr>
            <p:cNvSpPr txBox="1"/>
            <p:nvPr/>
          </p:nvSpPr>
          <p:spPr>
            <a:xfrm>
              <a:off x="1521652" y="1626931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ax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DFE6223-C96A-9340-B4E6-F0CF5A9EAC80}"/>
                </a:ext>
              </a:extLst>
            </p:cNvPr>
            <p:cNvSpPr txBox="1"/>
            <p:nvPr/>
          </p:nvSpPr>
          <p:spPr>
            <a:xfrm>
              <a:off x="4942707" y="1628425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in</a:t>
              </a:r>
            </a:p>
          </p:txBody>
        </p:sp>
      </p:grpSp>
      <p:grpSp>
        <p:nvGrpSpPr>
          <p:cNvPr id="80" name="Group 79">
            <a:extLst>
              <a:ext uri="{FF2B5EF4-FFF2-40B4-BE49-F238E27FC236}">
                <a16:creationId xmlns:a16="http://schemas.microsoft.com/office/drawing/2014/main" id="{3D3F9C2F-6A2D-3A41-A183-84D05EBA32D4}"/>
              </a:ext>
            </a:extLst>
          </p:cNvPr>
          <p:cNvGrpSpPr/>
          <p:nvPr/>
        </p:nvGrpSpPr>
        <p:grpSpPr>
          <a:xfrm>
            <a:off x="1517609" y="6323526"/>
            <a:ext cx="4174818" cy="400110"/>
            <a:chOff x="1521652" y="1586540"/>
            <a:chExt cx="4174818" cy="400110"/>
          </a:xfrm>
        </p:grpSpPr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1DCE77AD-442F-CE48-A4E2-5CCB8211B9BF}"/>
                </a:ext>
              </a:extLst>
            </p:cNvPr>
            <p:cNvSpPr txBox="1"/>
            <p:nvPr/>
          </p:nvSpPr>
          <p:spPr>
            <a:xfrm>
              <a:off x="2198037" y="1586540"/>
              <a:ext cx="7537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IQR </a:t>
              </a:r>
            </a:p>
            <a:p>
              <a:pPr algn="ctr"/>
              <a:r>
                <a:rPr lang="en-US" sz="1000" dirty="0"/>
                <a:t>Outlier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DE18B51A-3A41-4440-9744-10E455EDC946}"/>
                </a:ext>
              </a:extLst>
            </p:cNvPr>
            <p:cNvSpPr txBox="1"/>
            <p:nvPr/>
          </p:nvSpPr>
          <p:spPr>
            <a:xfrm>
              <a:off x="2825936" y="1633531"/>
              <a:ext cx="8633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3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BEE8D94A-9A60-5C4B-B799-8BF3751DE95B}"/>
                </a:ext>
              </a:extLst>
            </p:cNvPr>
            <p:cNvSpPr txBox="1"/>
            <p:nvPr/>
          </p:nvSpPr>
          <p:spPr>
            <a:xfrm>
              <a:off x="3593682" y="1633532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edian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B2661B36-FBAE-E949-A92D-29FC5FDD9897}"/>
                </a:ext>
              </a:extLst>
            </p:cNvPr>
            <p:cNvSpPr txBox="1"/>
            <p:nvPr/>
          </p:nvSpPr>
          <p:spPr>
            <a:xfrm>
              <a:off x="4279112" y="1631970"/>
              <a:ext cx="8921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1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B5CFD185-A67A-6D4A-A8A5-35646FCEAFE9}"/>
                </a:ext>
              </a:extLst>
            </p:cNvPr>
            <p:cNvSpPr txBox="1"/>
            <p:nvPr/>
          </p:nvSpPr>
          <p:spPr>
            <a:xfrm>
              <a:off x="1521652" y="1626931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ax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99112922-CD6B-4D42-8BFC-657FE673C2CD}"/>
                </a:ext>
              </a:extLst>
            </p:cNvPr>
            <p:cNvSpPr txBox="1"/>
            <p:nvPr/>
          </p:nvSpPr>
          <p:spPr>
            <a:xfrm>
              <a:off x="4942707" y="1628425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in</a:t>
              </a:r>
            </a:p>
          </p:txBody>
        </p:sp>
      </p:grpSp>
      <p:grpSp>
        <p:nvGrpSpPr>
          <p:cNvPr id="87" name="Group 86">
            <a:extLst>
              <a:ext uri="{FF2B5EF4-FFF2-40B4-BE49-F238E27FC236}">
                <a16:creationId xmlns:a16="http://schemas.microsoft.com/office/drawing/2014/main" id="{8788C6BB-04E4-7E41-A82D-886B3A817159}"/>
              </a:ext>
            </a:extLst>
          </p:cNvPr>
          <p:cNvGrpSpPr/>
          <p:nvPr/>
        </p:nvGrpSpPr>
        <p:grpSpPr>
          <a:xfrm>
            <a:off x="6903236" y="6300837"/>
            <a:ext cx="4174818" cy="400110"/>
            <a:chOff x="1521652" y="1586540"/>
            <a:chExt cx="4174818" cy="400110"/>
          </a:xfrm>
        </p:grpSpPr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6AD6ECFA-353D-CB4B-9FD4-E6097B0B92C3}"/>
                </a:ext>
              </a:extLst>
            </p:cNvPr>
            <p:cNvSpPr txBox="1"/>
            <p:nvPr/>
          </p:nvSpPr>
          <p:spPr>
            <a:xfrm>
              <a:off x="2198037" y="1586540"/>
              <a:ext cx="7537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IQR </a:t>
              </a:r>
            </a:p>
            <a:p>
              <a:pPr algn="ctr"/>
              <a:r>
                <a:rPr lang="en-US" sz="1000" dirty="0"/>
                <a:t>Outlier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C3E72FCE-C9B6-0A4F-9214-8BB2AE7DA266}"/>
                </a:ext>
              </a:extLst>
            </p:cNvPr>
            <p:cNvSpPr txBox="1"/>
            <p:nvPr/>
          </p:nvSpPr>
          <p:spPr>
            <a:xfrm>
              <a:off x="2825936" y="1633531"/>
              <a:ext cx="8633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3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69665BCA-6234-634A-B570-A4E7A24E778D}"/>
                </a:ext>
              </a:extLst>
            </p:cNvPr>
            <p:cNvSpPr txBox="1"/>
            <p:nvPr/>
          </p:nvSpPr>
          <p:spPr>
            <a:xfrm>
              <a:off x="3593682" y="1633532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edian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A7AC976F-95CF-B841-99A0-F9357AC3BC50}"/>
                </a:ext>
              </a:extLst>
            </p:cNvPr>
            <p:cNvSpPr txBox="1"/>
            <p:nvPr/>
          </p:nvSpPr>
          <p:spPr>
            <a:xfrm>
              <a:off x="4279112" y="1631970"/>
              <a:ext cx="8921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Q1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04A83C52-3FDC-E343-B139-C97A0986FA68}"/>
                </a:ext>
              </a:extLst>
            </p:cNvPr>
            <p:cNvSpPr txBox="1"/>
            <p:nvPr/>
          </p:nvSpPr>
          <p:spPr>
            <a:xfrm>
              <a:off x="1521652" y="1626931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ax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A7663A07-16F5-BF4C-951D-6AA4ABCEFABF}"/>
                </a:ext>
              </a:extLst>
            </p:cNvPr>
            <p:cNvSpPr txBox="1"/>
            <p:nvPr/>
          </p:nvSpPr>
          <p:spPr>
            <a:xfrm>
              <a:off x="4942707" y="1628425"/>
              <a:ext cx="753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Min</a:t>
              </a:r>
            </a:p>
          </p:txBody>
        </p:sp>
      </p:grpSp>
      <p:graphicFrame>
        <p:nvGraphicFramePr>
          <p:cNvPr id="95" name="Chart 94">
            <a:extLst>
              <a:ext uri="{FF2B5EF4-FFF2-40B4-BE49-F238E27FC236}">
                <a16:creationId xmlns:a16="http://schemas.microsoft.com/office/drawing/2014/main" id="{1FEC1B58-E7AA-EA40-990C-1FBD9203A8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7388581"/>
              </p:ext>
            </p:extLst>
          </p:nvPr>
        </p:nvGraphicFramePr>
        <p:xfrm>
          <a:off x="6903236" y="2077175"/>
          <a:ext cx="3941064" cy="2173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7" name="Chart 96">
            <a:extLst>
              <a:ext uri="{FF2B5EF4-FFF2-40B4-BE49-F238E27FC236}">
                <a16:creationId xmlns:a16="http://schemas.microsoft.com/office/drawing/2014/main" id="{4F58023A-B5BF-8F47-9BBF-A0B3E06634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3090090"/>
              </p:ext>
            </p:extLst>
          </p:nvPr>
        </p:nvGraphicFramePr>
        <p:xfrm>
          <a:off x="1516031" y="4308211"/>
          <a:ext cx="3941064" cy="2185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8" name="Chart 97">
            <a:extLst>
              <a:ext uri="{FF2B5EF4-FFF2-40B4-BE49-F238E27FC236}">
                <a16:creationId xmlns:a16="http://schemas.microsoft.com/office/drawing/2014/main" id="{77619998-98E4-7245-8DFC-4A4B82145B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2964673"/>
              </p:ext>
            </p:extLst>
          </p:nvPr>
        </p:nvGraphicFramePr>
        <p:xfrm>
          <a:off x="6915748" y="4289720"/>
          <a:ext cx="3941064" cy="2185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3124662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72</TotalTime>
  <Words>192</Words>
  <Application>Microsoft Macintosh PowerPoint</Application>
  <PresentationFormat>Widescreen</PresentationFormat>
  <Paragraphs>9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e Korponay</dc:creator>
  <cp:lastModifiedBy>Cole Korponay</cp:lastModifiedBy>
  <cp:revision>21</cp:revision>
  <dcterms:created xsi:type="dcterms:W3CDTF">2021-03-23T16:19:17Z</dcterms:created>
  <dcterms:modified xsi:type="dcterms:W3CDTF">2021-06-02T18:22:03Z</dcterms:modified>
</cp:coreProperties>
</file>